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91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735889-2EA8-8722-0E50-314177453677}" name="森村洋行" initials="森村洋行" userId="S::morimura.hiroyuki@aist.go.jp::ed211b07-d528-444b-bd35-06dc1e2a91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82155"/>
    <a:srgbClr val="DDCE76"/>
    <a:srgbClr val="0070C0"/>
    <a:srgbClr val="4F9136"/>
    <a:srgbClr val="AA4399"/>
    <a:srgbClr val="CC6577"/>
    <a:srgbClr val="E8E6E6"/>
    <a:srgbClr val="9EBCF5"/>
    <a:srgbClr val="322288"/>
    <a:srgbClr val="92D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7495"/>
  </p:normalViewPr>
  <p:slideViewPr>
    <p:cSldViewPr snapToGrid="0">
      <p:cViewPr>
        <p:scale>
          <a:sx n="124" d="100"/>
          <a:sy n="124" d="100"/>
        </p:scale>
        <p:origin x="738" y="-2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EA505-B48D-C94B-A6FC-D17AA2AC95E4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5CB18D-D601-8240-A5D2-0C713B2143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1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6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62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140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951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94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6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01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1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2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F5DB3C99-C51C-AFCB-56FB-EBF30B7B7285}"/>
              </a:ext>
            </a:extLst>
          </p:cNvPr>
          <p:cNvGrpSpPr/>
          <p:nvPr/>
        </p:nvGrpSpPr>
        <p:grpSpPr>
          <a:xfrm>
            <a:off x="1018523" y="2558460"/>
            <a:ext cx="4656159" cy="3503030"/>
            <a:chOff x="1018523" y="2558460"/>
            <a:chExt cx="4656159" cy="3503030"/>
          </a:xfrm>
        </p:grpSpPr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89A0395-D326-764D-68C3-2C3E998340AA}"/>
                </a:ext>
              </a:extLst>
            </p:cNvPr>
            <p:cNvSpPr txBox="1"/>
            <p:nvPr/>
          </p:nvSpPr>
          <p:spPr>
            <a:xfrm>
              <a:off x="1018523" y="4861161"/>
              <a:ext cx="4558668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S1 Fig. Pictures of </a:t>
              </a:r>
              <a:r>
                <a:rPr lang="en-US" altLang="ko-KR" sz="900" b="1" i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R. </a:t>
              </a:r>
              <a:r>
                <a:rPr lang="en-US" altLang="ko-KR" sz="900" b="1" i="1" dirty="0" err="1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pedestris</a:t>
              </a:r>
              <a:r>
                <a:rPr lang="en-US" altLang="ko-KR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. </a:t>
              </a:r>
              <a:r>
                <a:rPr lang="en-US" altLang="ko-KR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(</a:t>
              </a:r>
              <a:r>
                <a:rPr lang="en-US" altLang="ko-KR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A</a:t>
              </a:r>
              <a:r>
                <a:rPr lang="en-US" altLang="ko-KR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)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Female adult of </a:t>
              </a:r>
              <a:r>
                <a:rPr lang="en-US" altLang="ja-JP" sz="900" i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R. pedestris. 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(</a:t>
              </a:r>
              <a:r>
                <a:rPr lang="en-US" altLang="ja-JP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B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) Photograph of the whole midgut of </a:t>
              </a:r>
              <a:r>
                <a:rPr lang="en-US" altLang="ja-JP" sz="900" i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R. pedestris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. Abbreviations: M1, midgut first region; M2, midgut second region; M3, midgut third region; CR, constricted region; M4B, anterior bulb of midgut region; M4, midgut fourth region with crypts; H, hindgut.  (</a:t>
              </a:r>
              <a:r>
                <a:rPr lang="en-US" altLang="ja-JP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C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) Enlarged picture of the M4. (</a:t>
              </a:r>
              <a:r>
                <a:rPr lang="en-US" altLang="ja-JP" sz="9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D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) Developing trachea within the M4. The thin black tubes are trachea, observed here developing in the crypt.</a:t>
              </a:r>
              <a:r>
                <a:rPr lang="ja-JP" altLang="en-US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lang="en-US" altLang="ja-JP" sz="9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The asterisk represents the main duct passing through the middle of the M4.</a:t>
              </a:r>
            </a:p>
            <a:p>
              <a:pPr algn="just"/>
              <a:endParaRPr lang="en-US" altLang="ja-JP" sz="9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3DE2E946-E87D-7078-D1AC-3F992C8D42CC}"/>
                </a:ext>
              </a:extLst>
            </p:cNvPr>
            <p:cNvGrpSpPr/>
            <p:nvPr/>
          </p:nvGrpSpPr>
          <p:grpSpPr>
            <a:xfrm>
              <a:off x="1018523" y="2558460"/>
              <a:ext cx="1731233" cy="2240221"/>
              <a:chOff x="1018523" y="2558460"/>
              <a:chExt cx="1731233" cy="2240221"/>
            </a:xfrm>
          </p:grpSpPr>
          <p:pic>
            <p:nvPicPr>
              <p:cNvPr id="11" name="図 10" descr="屋内, 食品, フルーツ, バナナ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AA05889-C672-DA22-8979-EBE04F1B09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2950"/>
              <a:stretch/>
            </p:blipFill>
            <p:spPr>
              <a:xfrm>
                <a:off x="1018523" y="2558460"/>
                <a:ext cx="1731233" cy="2240221"/>
              </a:xfrm>
              <a:prstGeom prst="rect">
                <a:avLst/>
              </a:prstGeom>
            </p:spPr>
          </p:pic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ACB1E6FE-C30F-BCDC-67F8-6C9177014573}"/>
                  </a:ext>
                </a:extLst>
              </p:cNvPr>
              <p:cNvSpPr txBox="1"/>
              <p:nvPr/>
            </p:nvSpPr>
            <p:spPr>
              <a:xfrm>
                <a:off x="1052135" y="2558460"/>
                <a:ext cx="3015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A</a:t>
                </a: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9E4314B6-4A9A-A7A6-AC1B-F806CAA6CD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78821" y="4667283"/>
                <a:ext cx="484011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DD9492AD-4C08-15D0-F162-CA6715E8CA72}"/>
                  </a:ext>
                </a:extLst>
              </p:cNvPr>
              <p:cNvSpPr txBox="1"/>
              <p:nvPr/>
            </p:nvSpPr>
            <p:spPr>
              <a:xfrm>
                <a:off x="2109133" y="4482487"/>
                <a:ext cx="6233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5 mm</a:t>
                </a:r>
              </a:p>
            </p:txBody>
          </p:sp>
        </p:grpSp>
        <p:grpSp>
          <p:nvGrpSpPr>
            <p:cNvPr id="69" name="グループ化 68">
              <a:extLst>
                <a:ext uri="{FF2B5EF4-FFF2-40B4-BE49-F238E27FC236}">
                  <a16:creationId xmlns:a16="http://schemas.microsoft.com/office/drawing/2014/main" id="{4F5BED80-3A7C-1B05-A2C6-534C02903B84}"/>
                </a:ext>
              </a:extLst>
            </p:cNvPr>
            <p:cNvGrpSpPr/>
            <p:nvPr/>
          </p:nvGrpSpPr>
          <p:grpSpPr>
            <a:xfrm>
              <a:off x="4553734" y="3774301"/>
              <a:ext cx="1120948" cy="1024379"/>
              <a:chOff x="4553734" y="3774301"/>
              <a:chExt cx="1120948" cy="1024379"/>
            </a:xfrm>
          </p:grpSpPr>
          <p:pic>
            <p:nvPicPr>
              <p:cNvPr id="17" name="図 16" descr="屋外, 木, 線画, 雪 が含まれている画像&#10;&#10;自動的に生成された説明">
                <a:extLst>
                  <a:ext uri="{FF2B5EF4-FFF2-40B4-BE49-F238E27FC236}">
                    <a16:creationId xmlns:a16="http://schemas.microsoft.com/office/drawing/2014/main" id="{141A22EA-EF78-C5F7-9F7D-1EA7E58006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5000"/>
                        </a14:imgEffect>
                      </a14:imgLayer>
                    </a14:imgProps>
                  </a:ext>
                </a:extLst>
              </a:blip>
              <a:srcRect t="2105" r="855"/>
              <a:stretch/>
            </p:blipFill>
            <p:spPr>
              <a:xfrm rot="5400000">
                <a:off x="4554582" y="3776072"/>
                <a:ext cx="1021761" cy="1023456"/>
              </a:xfrm>
              <a:prstGeom prst="rect">
                <a:avLst/>
              </a:prstGeom>
            </p:spPr>
          </p:pic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E582CAED-7B3E-C121-8E4D-660D40F9FDA4}"/>
                  </a:ext>
                </a:extLst>
              </p:cNvPr>
              <p:cNvSpPr txBox="1"/>
              <p:nvPr/>
            </p:nvSpPr>
            <p:spPr>
              <a:xfrm>
                <a:off x="4553734" y="3774301"/>
                <a:ext cx="1715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D</a:t>
                </a: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D982796E-D59E-978B-E04D-0C154A80AE00}"/>
                  </a:ext>
                </a:extLst>
              </p:cNvPr>
              <p:cNvSpPr txBox="1"/>
              <p:nvPr/>
            </p:nvSpPr>
            <p:spPr>
              <a:xfrm>
                <a:off x="5051297" y="4589296"/>
                <a:ext cx="623385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dirty="0">
                    <a:solidFill>
                      <a:sysClr val="windowText" lastClr="000000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100 µm</a:t>
                </a:r>
              </a:p>
            </p:txBody>
          </p: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id="{20108552-7CC9-6E92-6AD7-532AE78318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52314" y="4757817"/>
                <a:ext cx="25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B99A962B-22C6-9D3A-D1CF-7C7AEEEFC5AD}"/>
                  </a:ext>
                </a:extLst>
              </p:cNvPr>
              <p:cNvSpPr txBox="1"/>
              <p:nvPr/>
            </p:nvSpPr>
            <p:spPr>
              <a:xfrm>
                <a:off x="4953806" y="4499897"/>
                <a:ext cx="1715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*</a:t>
                </a:r>
              </a:p>
            </p:txBody>
          </p:sp>
        </p:grp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id="{70DBB3CF-5A6B-B5F5-93BA-9E315F5D4F38}"/>
                </a:ext>
              </a:extLst>
            </p:cNvPr>
            <p:cNvGrpSpPr/>
            <p:nvPr/>
          </p:nvGrpSpPr>
          <p:grpSpPr>
            <a:xfrm>
              <a:off x="2856876" y="3776919"/>
              <a:ext cx="1606875" cy="1021763"/>
              <a:chOff x="2856876" y="3776919"/>
              <a:chExt cx="1606875" cy="1021763"/>
            </a:xfrm>
          </p:grpSpPr>
          <p:pic>
            <p:nvPicPr>
              <p:cNvPr id="9" name="図 8" descr="夜の街のイラスト&#10;&#10;中程度の精度で自動的に生成された説明">
                <a:extLst>
                  <a:ext uri="{FF2B5EF4-FFF2-40B4-BE49-F238E27FC236}">
                    <a16:creationId xmlns:a16="http://schemas.microsoft.com/office/drawing/2014/main" id="{3D7C2D95-E0DC-EF53-D0AE-5FF1DB5AE3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61651" t="43386" r="22141" b="38095"/>
              <a:stretch/>
            </p:blipFill>
            <p:spPr>
              <a:xfrm>
                <a:off x="2856876" y="3776919"/>
                <a:ext cx="1589738" cy="1021763"/>
              </a:xfrm>
              <a:prstGeom prst="rect">
                <a:avLst/>
              </a:prstGeom>
              <a:ln w="28575">
                <a:noFill/>
              </a:ln>
            </p:spPr>
          </p:pic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9213D68E-6A10-2744-85E4-E3DC4CAF95AE}"/>
                  </a:ext>
                </a:extLst>
              </p:cNvPr>
              <p:cNvSpPr txBox="1"/>
              <p:nvPr/>
            </p:nvSpPr>
            <p:spPr>
              <a:xfrm>
                <a:off x="2856876" y="3776919"/>
                <a:ext cx="17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C</a:t>
                </a: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FB37FAE3-7E49-A6FD-A4FB-82AC84F4A9E2}"/>
                  </a:ext>
                </a:extLst>
              </p:cNvPr>
              <p:cNvSpPr txBox="1"/>
              <p:nvPr/>
            </p:nvSpPr>
            <p:spPr>
              <a:xfrm>
                <a:off x="3840366" y="4508027"/>
                <a:ext cx="6233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0.5 mm</a:t>
                </a:r>
              </a:p>
            </p:txBody>
          </p: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FC7202B0-F4A3-506F-EFE3-D175383ADF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52675" y="4708147"/>
                <a:ext cx="252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B2D6A5FF-8D29-BEE9-CE91-701A1954C04E}"/>
                  </a:ext>
                </a:extLst>
              </p:cNvPr>
              <p:cNvSpPr txBox="1"/>
              <p:nvPr/>
            </p:nvSpPr>
            <p:spPr>
              <a:xfrm>
                <a:off x="2962065" y="4569181"/>
                <a:ext cx="4184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4</a:t>
                </a:r>
              </a:p>
            </p:txBody>
          </p:sp>
        </p:grp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CB0A69B8-BB9B-E3FB-D594-5F6196FC448C}"/>
                </a:ext>
              </a:extLst>
            </p:cNvPr>
            <p:cNvGrpSpPr/>
            <p:nvPr/>
          </p:nvGrpSpPr>
          <p:grpSpPr>
            <a:xfrm>
              <a:off x="2839589" y="2558460"/>
              <a:ext cx="2824205" cy="1196108"/>
              <a:chOff x="2839589" y="2558460"/>
              <a:chExt cx="2824205" cy="1196108"/>
            </a:xfrm>
          </p:grpSpPr>
          <p:pic>
            <p:nvPicPr>
              <p:cNvPr id="3" name="図 2" descr="動物, 暗い, 海洋生物, 水 が含まれている画像&#10;&#10;自動的に生成された説明">
                <a:extLst>
                  <a:ext uri="{FF2B5EF4-FFF2-40B4-BE49-F238E27FC236}">
                    <a16:creationId xmlns:a16="http://schemas.microsoft.com/office/drawing/2014/main" id="{15A61A19-D352-7257-2EDD-F4735234D6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t="15134" b="7916"/>
              <a:stretch/>
            </p:blipFill>
            <p:spPr>
              <a:xfrm>
                <a:off x="2856876" y="2558460"/>
                <a:ext cx="2720315" cy="1177490"/>
              </a:xfrm>
              <a:prstGeom prst="rect">
                <a:avLst/>
              </a:prstGeom>
            </p:spPr>
          </p:pic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A0DC7394-2BD9-014D-C45C-F87380ECD1A5}"/>
                  </a:ext>
                </a:extLst>
              </p:cNvPr>
              <p:cNvSpPr txBox="1"/>
              <p:nvPr/>
            </p:nvSpPr>
            <p:spPr>
              <a:xfrm>
                <a:off x="2856877" y="2558460"/>
                <a:ext cx="17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B</a:t>
                </a: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9E30C22B-BCE5-0EEA-2E6A-97A5CDD2A6E5}"/>
                  </a:ext>
                </a:extLst>
              </p:cNvPr>
              <p:cNvSpPr txBox="1"/>
              <p:nvPr/>
            </p:nvSpPr>
            <p:spPr>
              <a:xfrm>
                <a:off x="4953806" y="2558624"/>
                <a:ext cx="6233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2 mm</a:t>
                </a:r>
              </a:p>
            </p:txBody>
          </p: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52C0AD1D-84E9-41BC-EEC3-3435D676D8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91002" y="2764119"/>
                <a:ext cx="38266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7E3F3A96-A4D5-F7D5-252A-EEA03E0F31A6}"/>
                  </a:ext>
                </a:extLst>
              </p:cNvPr>
              <p:cNvSpPr txBox="1"/>
              <p:nvPr/>
            </p:nvSpPr>
            <p:spPr>
              <a:xfrm>
                <a:off x="2839589" y="3039483"/>
                <a:ext cx="3793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1</a:t>
                </a: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9A62ECA5-4B15-52AD-33F6-44FAAEBD771D}"/>
                  </a:ext>
                </a:extLst>
              </p:cNvPr>
              <p:cNvSpPr txBox="1"/>
              <p:nvPr/>
            </p:nvSpPr>
            <p:spPr>
              <a:xfrm>
                <a:off x="3878091" y="3484061"/>
                <a:ext cx="3793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2</a:t>
                </a: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D2DF055B-0A78-ABC1-2ACB-BBC4ED87B5C9}"/>
                  </a:ext>
                </a:extLst>
              </p:cNvPr>
              <p:cNvSpPr txBox="1"/>
              <p:nvPr/>
            </p:nvSpPr>
            <p:spPr>
              <a:xfrm>
                <a:off x="4217033" y="2637849"/>
                <a:ext cx="3793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3</a:t>
                </a: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58594286-C530-87B2-928B-F2F648DF5140}"/>
                  </a:ext>
                </a:extLst>
              </p:cNvPr>
              <p:cNvSpPr txBox="1"/>
              <p:nvPr/>
            </p:nvSpPr>
            <p:spPr>
              <a:xfrm>
                <a:off x="4028396" y="3223627"/>
                <a:ext cx="3793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CR</a:t>
                </a: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9C9CEA31-E202-581F-1798-78926BEB01DC}"/>
                  </a:ext>
                </a:extLst>
              </p:cNvPr>
              <p:cNvSpPr txBox="1"/>
              <p:nvPr/>
            </p:nvSpPr>
            <p:spPr>
              <a:xfrm>
                <a:off x="4442084" y="3539124"/>
                <a:ext cx="4184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4B</a:t>
                </a: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93924186-E2EC-1A3E-7BB6-95203795CDFD}"/>
                  </a:ext>
                </a:extLst>
              </p:cNvPr>
              <p:cNvSpPr txBox="1"/>
              <p:nvPr/>
            </p:nvSpPr>
            <p:spPr>
              <a:xfrm>
                <a:off x="4709549" y="2820510"/>
                <a:ext cx="4184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M4</a:t>
                </a: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41A519AF-35A9-5B04-1F94-7056E5328E58}"/>
                  </a:ext>
                </a:extLst>
              </p:cNvPr>
              <p:cNvSpPr txBox="1"/>
              <p:nvPr/>
            </p:nvSpPr>
            <p:spPr>
              <a:xfrm>
                <a:off x="5245319" y="2890823"/>
                <a:ext cx="4184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rPr>
                  <a:t>H</a:t>
                </a:r>
              </a:p>
            </p:txBody>
          </p: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D0F976C5-5394-E398-ADF8-2B714C3D27D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88801" y="3127520"/>
                <a:ext cx="219982" cy="19685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30CB60B0-9D4A-1647-4799-6E4C698889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78090" y="3393071"/>
                <a:ext cx="157102" cy="114226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C6AB6864-2EB2-4C5A-B4BE-95CBE946F82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91786" y="2798213"/>
                <a:ext cx="103053" cy="200332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C65E2B44-A63C-3058-10A3-3556F834590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65750" y="3147205"/>
                <a:ext cx="198001" cy="151377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D9D4B759-8256-8921-79E7-FF50B44091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30785" y="3393071"/>
                <a:ext cx="0" cy="171733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id="{BC1E7C5D-585C-941E-0720-BB1BFF58F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2517" y="2975472"/>
                <a:ext cx="0" cy="171733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id="{80DF03F5-3501-7B8D-B697-84868DEC60C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282334" y="3056127"/>
                <a:ext cx="71977" cy="238732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260696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96</TotalTime>
  <Words>144</Words>
  <Application>Microsoft Office PowerPoint</Application>
  <PresentationFormat>A4 210 x 297 mm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村洋行</dc:creator>
  <cp:lastModifiedBy>菊池義智</cp:lastModifiedBy>
  <cp:revision>246</cp:revision>
  <cp:lastPrinted>2023-04-03T02:46:52Z</cp:lastPrinted>
  <dcterms:created xsi:type="dcterms:W3CDTF">2023-03-01T02:57:03Z</dcterms:created>
  <dcterms:modified xsi:type="dcterms:W3CDTF">2024-10-07T13:38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3-05-01T09:10:28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9c687925-788e-4260-a124-624eb367c218</vt:lpwstr>
  </property>
  <property fmtid="{D5CDD505-2E9C-101B-9397-08002B2CF9AE}" pid="8" name="MSIP_Label_ddc55989-3c9e-4466-8514-eac6f80f6373_ContentBits">
    <vt:lpwstr>0</vt:lpwstr>
  </property>
</Properties>
</file>